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7200" y="6367790"/>
            <a:ext cx="838200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100" b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7 </a:t>
            </a:r>
            <a:r>
              <a:rPr lang="en-US" sz="11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Distribution of conserved motifs in </a:t>
            </a:r>
            <a:r>
              <a:rPr lang="en-US" sz="1100" dirty="0" err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bHyPRPs</a:t>
            </a:r>
            <a:r>
              <a:rPr lang="en-US" sz="11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The scale represents the lengths of the proteins and motifs </a:t>
            </a:r>
            <a:endParaRPr lang="en-US" sz="110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/>
          <a:srcRect l="1757" t="2083" r="2196" b="6250"/>
          <a:stretch>
            <a:fillRect/>
          </a:stretch>
        </p:blipFill>
        <p:spPr bwMode="auto">
          <a:xfrm>
            <a:off x="0" y="80946"/>
            <a:ext cx="9067801" cy="60150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2</cp:revision>
  <dcterms:created xsi:type="dcterms:W3CDTF">2006-08-16T00:00:00Z</dcterms:created>
  <dcterms:modified xsi:type="dcterms:W3CDTF">2022-08-06T06:51:22Z</dcterms:modified>
</cp:coreProperties>
</file>